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1"/>
  </p:notesMasterIdLst>
  <p:sldIdLst>
    <p:sldId id="256" r:id="rId2"/>
    <p:sldId id="274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3" r:id="rId18"/>
    <p:sldId id="271" r:id="rId19"/>
    <p:sldId id="272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502"/>
    <p:restoredTop sz="96327"/>
  </p:normalViewPr>
  <p:slideViewPr>
    <p:cSldViewPr snapToGrid="0" snapToObjects="1">
      <p:cViewPr>
        <p:scale>
          <a:sx n="92" d="100"/>
          <a:sy n="92" d="100"/>
        </p:scale>
        <p:origin x="-232" y="1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6FF1D9-7C74-9A41-987A-E032F925D32A}" type="datetimeFigureOut">
              <a:rPr lang="en-US" smtClean="0"/>
              <a:t>3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46310-3C67-F544-85CA-762A3CF73B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748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246870-8730-E54C-A2AB-1DD1525115C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494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246870-8730-E54C-A2AB-1DD1525115CD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3052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246870-8730-E54C-A2AB-1DD1525115CD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723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CD4C5-349D-C540-A7E8-D0B21411B0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12C9FF-C8A5-8B46-B875-205EC5602F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9C74F9-B840-2545-A332-45659A0DC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3CF25D-375B-FD41-8DA5-B38C9C95A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96B726-32B3-BF4F-90C7-552CE871D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471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4EF68-0DE3-A540-955F-8D4E8B0F0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94C708-3328-8A48-96CD-BFD69DD108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3FE6D5-58AB-9A47-A561-0C26208B4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84F088-FF45-A74E-B63D-AFDC0BE43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B0E7B7-4E52-4B44-85B7-66C3EBB492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749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E6C0F7-90AE-464A-8CBF-D40560E4D5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77E0BF-234B-014D-98AD-D404E9FE6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9247D2-5F60-0944-B896-75C492151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97395C-4656-324E-B664-4AABA40AA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B1C994-2ACD-7C47-BDA2-222CE663C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371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38E78-7318-F14C-A5FF-1A72A5994F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2962BC-A62E-C14F-9366-5E19D57CD2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956B34-5E2C-624C-8F5C-5FF50F174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957314-66B8-6445-ADE5-08B84017B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631DFA-8F88-9441-97DB-431F7ACCE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233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F21D30-2022-0547-87A5-0A03EFF0F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886682-D473-D94E-B5DC-30BBEAE5A3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E475B3-36B3-734B-8C01-6D717606C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62384B-B50B-0D47-ADBD-0DD418C63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DD91C8-1574-6643-83A1-8C715CFD6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859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21F91D-1D5C-EB46-9747-0A00500A0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577874-FF32-CE44-A9B0-A6FCA522C2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49301D-1597-234E-BEEB-2A68AADEE2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5A6C14-9CDC-A04F-B6A3-FCB5B76E9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F1EB1D-BBCE-4E42-83C7-D92B0CF34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44CEBB-3E42-2B40-BD2D-906C15E26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695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CF5972-9708-8641-A5F0-6352547A46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7C705E-D488-EF4B-8C2A-90EE99BDED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B26AA5-D519-C347-ADFA-39E8B4994C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090867-DB8D-5241-B215-316B6C6433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46D61B-46CC-8045-AAD0-5788D0E2D0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8C2420-4F7B-D948-AAF7-FEBCD2B9C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CF0C00-1C6C-DE46-8B8D-6E90F4650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AC339F-0C7B-F34B-86F2-C713BC1EE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946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D2ABC7-C675-EB4F-BF56-26F4196D5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1B7ED5-B2B9-1040-B025-B7D7E8059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6B9E7C-FA4F-D94C-B522-8CA013F5C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5F124C-8771-AF49-A12A-6F2616B52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37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37E022-B7E1-1E4B-815E-018A8E156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473D81-DBBF-8241-AA92-DF014FB01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369021-B322-8C43-8D8F-80E48F440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538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E98400-8097-8545-AE8B-87B950CD88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4BF8CF-8C7F-9E43-B2B3-52DD08A10F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7F3FDF-602B-4247-8DE6-6AF3DBD8A7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BE01A2-CB95-D247-B29B-D33A025F5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A156FB-68F7-434C-9FA0-89C1FAE49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BF2F82-FE8C-EC41-8A73-68404286D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23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988E20-2E6B-AE49-93C1-111BFFB72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0C46A0-25F4-EA4F-A393-40D65051FF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5DA326-CE7F-BA4F-886A-531C051F8A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232F76-4FB3-6042-BE30-21465413A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7DD6AC-FD6B-BF41-8F93-A885F45FF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427FE8-2F80-EA41-A480-A2C80813C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690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2CE16E8-3600-A54A-AC62-4FD63C8D8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B5C8DF-626A-C142-871C-7A4F53B1F3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372119-AEED-4B41-A075-4772D1FB79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7EE49-D4E0-E448-BCB4-956908A02CB3}" type="datetimeFigureOut">
              <a:rPr lang="en-US" smtClean="0"/>
              <a:t>3/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CB1D7-5E72-3448-A6C5-4A759EEC32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66C524-274A-D841-9CD1-CA4FCEA75E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67FC68-0534-D646-BD50-5E9369B03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69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849AA1-C0B3-A74B-B105-13A268F2C5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385600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ixed-effects logistic regression model outputs for individual news outlets and </a:t>
            </a:r>
            <a:r>
              <a:rPr lang="en-US" b="0" i="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urekAlert</a:t>
            </a:r>
            <a:r>
              <a:rPr lang="en-US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!</a:t>
            </a:r>
            <a:endParaRPr 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966BC1-7B45-774A-BF00-1BB3BBFF16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001511"/>
            <a:ext cx="9144000" cy="1655762"/>
          </a:xfrm>
        </p:spPr>
        <p:txBody>
          <a:bodyPr/>
          <a:lstStyle/>
          <a:p>
            <a:r>
              <a:rPr lang="en-US" dirty="0"/>
              <a:t>Supplementary STATA outputs</a:t>
            </a:r>
          </a:p>
        </p:txBody>
      </p:sp>
    </p:spTree>
    <p:extLst>
      <p:ext uri="{BB962C8B-B14F-4D97-AF65-F5344CB8AC3E}">
        <p14:creationId xmlns:p14="http://schemas.microsoft.com/office/powerpoint/2010/main" val="37541803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2104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ational Geographic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46F94C24-0DA7-DB47-85D0-37C2EC6682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7750" y="660400"/>
            <a:ext cx="7556500" cy="55372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F1A82E6-CCD7-8943-9221-CC59527792A0}"/>
              </a:ext>
            </a:extLst>
          </p:cNvPr>
          <p:cNvSpPr/>
          <p:nvPr/>
        </p:nvSpPr>
        <p:spPr>
          <a:xfrm>
            <a:off x="5846152" y="1899738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565368E-459A-BA4C-9928-7DE7434495D8}"/>
              </a:ext>
            </a:extLst>
          </p:cNvPr>
          <p:cNvSpPr/>
          <p:nvPr/>
        </p:nvSpPr>
        <p:spPr>
          <a:xfrm>
            <a:off x="5458409" y="2244143"/>
            <a:ext cx="925792" cy="261598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C2D5CAF-2D00-204D-AB78-DB9AD0BD60F5}"/>
              </a:ext>
            </a:extLst>
          </p:cNvPr>
          <p:cNvSpPr/>
          <p:nvPr/>
        </p:nvSpPr>
        <p:spPr>
          <a:xfrm>
            <a:off x="5884506" y="5679057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52995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984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scover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78EF0FC5-52DE-6145-852E-9D6357CFF2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5050" y="660400"/>
            <a:ext cx="7581900" cy="55372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03D6221-6438-DE43-B1E6-154816F933D1}"/>
              </a:ext>
            </a:extLst>
          </p:cNvPr>
          <p:cNvSpPr/>
          <p:nvPr/>
        </p:nvSpPr>
        <p:spPr>
          <a:xfrm>
            <a:off x="5939458" y="160020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265EA05-43DA-F543-88FA-BA1B628B9C3F}"/>
              </a:ext>
            </a:extLst>
          </p:cNvPr>
          <p:cNvSpPr/>
          <p:nvPr/>
        </p:nvSpPr>
        <p:spPr>
          <a:xfrm>
            <a:off x="2305051" y="1911220"/>
            <a:ext cx="4134102" cy="751018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C28A7A0-DE6E-054D-9CFA-98F7D0170B1B}"/>
              </a:ext>
            </a:extLst>
          </p:cNvPr>
          <p:cNvSpPr/>
          <p:nvPr/>
        </p:nvSpPr>
        <p:spPr>
          <a:xfrm>
            <a:off x="5912497" y="5714189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4F308E4-B6B9-E849-9A78-97D08DF2DD3A}"/>
              </a:ext>
            </a:extLst>
          </p:cNvPr>
          <p:cNvSpPr/>
          <p:nvPr/>
        </p:nvSpPr>
        <p:spPr>
          <a:xfrm>
            <a:off x="5939457" y="2974587"/>
            <a:ext cx="499695" cy="36577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71767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1451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ew Scientist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AC179324-E0AA-484E-B062-B05F0542BC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5050" y="654050"/>
            <a:ext cx="7581900" cy="55499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7930B3D7-E03E-2140-95CA-6F46F9515350}"/>
              </a:ext>
            </a:extLst>
          </p:cNvPr>
          <p:cNvSpPr/>
          <p:nvPr/>
        </p:nvSpPr>
        <p:spPr>
          <a:xfrm>
            <a:off x="5939458" y="160020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3684A70-CC68-3645-8EAF-9B8F7B978755}"/>
              </a:ext>
            </a:extLst>
          </p:cNvPr>
          <p:cNvSpPr/>
          <p:nvPr/>
        </p:nvSpPr>
        <p:spPr>
          <a:xfrm>
            <a:off x="5939457" y="1929882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79E1D57-31DF-BE4B-B0C9-6C0849263944}"/>
              </a:ext>
            </a:extLst>
          </p:cNvPr>
          <p:cNvSpPr/>
          <p:nvPr/>
        </p:nvSpPr>
        <p:spPr>
          <a:xfrm>
            <a:off x="5421086" y="2279199"/>
            <a:ext cx="1018065" cy="263035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18464E9-72AE-DD47-9418-25465CD65C04}"/>
              </a:ext>
            </a:extLst>
          </p:cNvPr>
          <p:cNvSpPr/>
          <p:nvPr/>
        </p:nvSpPr>
        <p:spPr>
          <a:xfrm>
            <a:off x="5903163" y="5349875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F62109D-1230-5940-B752-CB9A3C08AD73}"/>
              </a:ext>
            </a:extLst>
          </p:cNvPr>
          <p:cNvSpPr/>
          <p:nvPr/>
        </p:nvSpPr>
        <p:spPr>
          <a:xfrm>
            <a:off x="5846152" y="5663617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12259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ewsweek</a:t>
            </a:r>
          </a:p>
        </p:txBody>
      </p:sp>
      <p:pic>
        <p:nvPicPr>
          <p:cNvPr id="5" name="Picture 4" descr="A document with numbers and text&#10;&#10;Description automatically generated">
            <a:extLst>
              <a:ext uri="{FF2B5EF4-FFF2-40B4-BE49-F238E27FC236}">
                <a16:creationId xmlns:a16="http://schemas.microsoft.com/office/drawing/2014/main" id="{FBD92A63-6E64-C04B-AE57-750DDE6C8F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4100" y="641350"/>
            <a:ext cx="7543800" cy="55753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1B6E483-38FD-BB45-8B29-22BD8B111BA1}"/>
              </a:ext>
            </a:extLst>
          </p:cNvPr>
          <p:cNvSpPr/>
          <p:nvPr/>
        </p:nvSpPr>
        <p:spPr>
          <a:xfrm>
            <a:off x="5939457" y="160020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731C836-BB32-354D-A1B2-6C446D772812}"/>
              </a:ext>
            </a:extLst>
          </p:cNvPr>
          <p:cNvSpPr/>
          <p:nvPr/>
        </p:nvSpPr>
        <p:spPr>
          <a:xfrm>
            <a:off x="2324101" y="1929880"/>
            <a:ext cx="4088090" cy="570723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163E7D5-56E8-C149-9E1B-9117463EB05C}"/>
              </a:ext>
            </a:extLst>
          </p:cNvPr>
          <p:cNvSpPr/>
          <p:nvPr/>
        </p:nvSpPr>
        <p:spPr>
          <a:xfrm>
            <a:off x="5939457" y="2953014"/>
            <a:ext cx="499695" cy="35510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0960B8E-0879-B746-9F75-6C1069BAADF7}"/>
              </a:ext>
            </a:extLst>
          </p:cNvPr>
          <p:cNvSpPr/>
          <p:nvPr/>
        </p:nvSpPr>
        <p:spPr>
          <a:xfrm>
            <a:off x="5939457" y="3744884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DA251B9-ADD9-F84B-B933-6DDB844033EB}"/>
              </a:ext>
            </a:extLst>
          </p:cNvPr>
          <p:cNvSpPr/>
          <p:nvPr/>
        </p:nvSpPr>
        <p:spPr>
          <a:xfrm>
            <a:off x="5505061" y="4444874"/>
            <a:ext cx="934091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31C7855-0D9C-0549-8F77-2C1307469FA4}"/>
              </a:ext>
            </a:extLst>
          </p:cNvPr>
          <p:cNvSpPr/>
          <p:nvPr/>
        </p:nvSpPr>
        <p:spPr>
          <a:xfrm>
            <a:off x="5914556" y="535973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320133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1974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ientific American</a:t>
            </a:r>
          </a:p>
        </p:txBody>
      </p:sp>
      <p:pic>
        <p:nvPicPr>
          <p:cNvPr id="5" name="Picture 4" descr="A document with numbers and text&#10;&#10;Description automatically generated">
            <a:extLst>
              <a:ext uri="{FF2B5EF4-FFF2-40B4-BE49-F238E27FC236}">
                <a16:creationId xmlns:a16="http://schemas.microsoft.com/office/drawing/2014/main" id="{FDC3D889-2256-1949-8A5F-3EE4D02DB2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7750" y="647700"/>
            <a:ext cx="7556500" cy="55626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0DF0147-17DF-084C-9A2A-59746E2E86A0}"/>
              </a:ext>
            </a:extLst>
          </p:cNvPr>
          <p:cNvSpPr/>
          <p:nvPr/>
        </p:nvSpPr>
        <p:spPr>
          <a:xfrm>
            <a:off x="2317751" y="1938612"/>
            <a:ext cx="4104384" cy="710925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D14C2F7-99CB-F84C-83D3-E7F4C520148F}"/>
              </a:ext>
            </a:extLst>
          </p:cNvPr>
          <p:cNvSpPr/>
          <p:nvPr/>
        </p:nvSpPr>
        <p:spPr>
          <a:xfrm>
            <a:off x="5922440" y="5235548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002EBFF-51FC-0748-B994-B1575B404BFE}"/>
              </a:ext>
            </a:extLst>
          </p:cNvPr>
          <p:cNvSpPr/>
          <p:nvPr/>
        </p:nvSpPr>
        <p:spPr>
          <a:xfrm>
            <a:off x="5922439" y="551799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594CED4-63C6-044E-9D8C-44ABB2E83049}"/>
              </a:ext>
            </a:extLst>
          </p:cNvPr>
          <p:cNvSpPr/>
          <p:nvPr/>
        </p:nvSpPr>
        <p:spPr>
          <a:xfrm>
            <a:off x="5486401" y="4434790"/>
            <a:ext cx="935734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DD7AD45-1DDF-7E4B-92B6-C871CC39FB93}"/>
              </a:ext>
            </a:extLst>
          </p:cNvPr>
          <p:cNvSpPr/>
          <p:nvPr/>
        </p:nvSpPr>
        <p:spPr>
          <a:xfrm>
            <a:off x="5912540" y="3663641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369531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816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orbes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E433933E-3060-8446-8726-CEA5E071F9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1400" y="660400"/>
            <a:ext cx="7569200" cy="55372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4855A0FE-ACB9-7341-AC7F-936F41D76CB5}"/>
              </a:ext>
            </a:extLst>
          </p:cNvPr>
          <p:cNvSpPr/>
          <p:nvPr/>
        </p:nvSpPr>
        <p:spPr>
          <a:xfrm>
            <a:off x="5906674" y="191557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12E560C-6429-454C-81AD-0E4B51083B65}"/>
              </a:ext>
            </a:extLst>
          </p:cNvPr>
          <p:cNvSpPr/>
          <p:nvPr/>
        </p:nvSpPr>
        <p:spPr>
          <a:xfrm>
            <a:off x="5906673" y="2267792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9096894-7978-A44E-8DF6-04985959902C}"/>
              </a:ext>
            </a:extLst>
          </p:cNvPr>
          <p:cNvSpPr/>
          <p:nvPr/>
        </p:nvSpPr>
        <p:spPr>
          <a:xfrm>
            <a:off x="5846152" y="3763803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595D6E4-CD90-7E44-9D8E-5319C6A78A87}"/>
              </a:ext>
            </a:extLst>
          </p:cNvPr>
          <p:cNvSpPr/>
          <p:nvPr/>
        </p:nvSpPr>
        <p:spPr>
          <a:xfrm>
            <a:off x="5891134" y="5712195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870186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1942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s Angeles Times</a:t>
            </a:r>
          </a:p>
        </p:txBody>
      </p:sp>
      <p:pic>
        <p:nvPicPr>
          <p:cNvPr id="5" name="Picture 4" descr="A document with numbers and letters&#10;&#10;Description automatically generated">
            <a:extLst>
              <a:ext uri="{FF2B5EF4-FFF2-40B4-BE49-F238E27FC236}">
                <a16:creationId xmlns:a16="http://schemas.microsoft.com/office/drawing/2014/main" id="{7AE17CC4-84D8-F94E-84E0-7FA2B7C9DB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8700" y="609600"/>
            <a:ext cx="7594600" cy="56388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ECD8C488-6734-EF44-8592-FDC2D5EC0FCF}"/>
              </a:ext>
            </a:extLst>
          </p:cNvPr>
          <p:cNvSpPr/>
          <p:nvPr/>
        </p:nvSpPr>
        <p:spPr>
          <a:xfrm>
            <a:off x="5924980" y="160020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1B758B6-BDBE-4E45-87B6-3C59264C271B}"/>
              </a:ext>
            </a:extLst>
          </p:cNvPr>
          <p:cNvSpPr/>
          <p:nvPr/>
        </p:nvSpPr>
        <p:spPr>
          <a:xfrm>
            <a:off x="5924980" y="1918138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9DAC4C3-40B8-E149-B10D-E4373AD13327}"/>
              </a:ext>
            </a:extLst>
          </p:cNvPr>
          <p:cNvSpPr/>
          <p:nvPr/>
        </p:nvSpPr>
        <p:spPr>
          <a:xfrm>
            <a:off x="5352394" y="2252072"/>
            <a:ext cx="1072282" cy="35936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364FE84-57B2-F448-9A84-96A5F4697656}"/>
              </a:ext>
            </a:extLst>
          </p:cNvPr>
          <p:cNvSpPr/>
          <p:nvPr/>
        </p:nvSpPr>
        <p:spPr>
          <a:xfrm>
            <a:off x="5924979" y="5214051"/>
            <a:ext cx="499695" cy="256583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874FA11-A971-EE4D-924A-E60B6DD27EDA}"/>
              </a:ext>
            </a:extLst>
          </p:cNvPr>
          <p:cNvSpPr/>
          <p:nvPr/>
        </p:nvSpPr>
        <p:spPr>
          <a:xfrm>
            <a:off x="5833240" y="5679834"/>
            <a:ext cx="615307" cy="129759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6A7E4A6-7DF7-A743-9AA4-A4AD3A829100}"/>
              </a:ext>
            </a:extLst>
          </p:cNvPr>
          <p:cNvSpPr/>
          <p:nvPr/>
        </p:nvSpPr>
        <p:spPr>
          <a:xfrm>
            <a:off x="6042991" y="2820638"/>
            <a:ext cx="352638" cy="127024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FC7059A-A6AB-344F-9531-20E76B09EE0A}"/>
              </a:ext>
            </a:extLst>
          </p:cNvPr>
          <p:cNvSpPr/>
          <p:nvPr/>
        </p:nvSpPr>
        <p:spPr>
          <a:xfrm>
            <a:off x="6042991" y="3166108"/>
            <a:ext cx="352638" cy="25658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520758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screenshot of a computer&#10;&#10;Description automatically generated">
            <a:extLst>
              <a:ext uri="{FF2B5EF4-FFF2-40B4-BE49-F238E27FC236}">
                <a16:creationId xmlns:a16="http://schemas.microsoft.com/office/drawing/2014/main" id="{07178429-089B-0043-8E83-CB172798CE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" y="88900"/>
            <a:ext cx="11277600" cy="6680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8650909" y="191850"/>
            <a:ext cx="25289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EurekAlert</a:t>
            </a:r>
            <a:r>
              <a:rPr lang="en-US" dirty="0"/>
              <a:t>! for Continent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8FBA4FD-BE21-5149-9F60-1F7FBDA0CF1C}"/>
              </a:ext>
            </a:extLst>
          </p:cNvPr>
          <p:cNvSpPr/>
          <p:nvPr/>
        </p:nvSpPr>
        <p:spPr>
          <a:xfrm>
            <a:off x="457201" y="2098040"/>
            <a:ext cx="6155414" cy="1082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F4F369A-B587-0842-8D08-4D81644BCDA3}"/>
              </a:ext>
            </a:extLst>
          </p:cNvPr>
          <p:cNvSpPr/>
          <p:nvPr/>
        </p:nvSpPr>
        <p:spPr>
          <a:xfrm>
            <a:off x="5486400" y="5277953"/>
            <a:ext cx="1092533" cy="220804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14478DF-B704-1341-80D5-4977EC07DA55}"/>
              </a:ext>
            </a:extLst>
          </p:cNvPr>
          <p:cNvSpPr/>
          <p:nvPr/>
        </p:nvSpPr>
        <p:spPr>
          <a:xfrm>
            <a:off x="6079238" y="3533881"/>
            <a:ext cx="499695" cy="90749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407922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769573-4989-8D49-B047-2624D8F9A72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35D2E2-4B6A-534B-BD52-2051CC7C21B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1BEC79EE-4818-B64D-9911-F84586ABF1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2500" y="0"/>
            <a:ext cx="102870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8650909" y="191850"/>
            <a:ext cx="2850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EurekAlert</a:t>
            </a:r>
            <a:r>
              <a:rPr lang="en-US" dirty="0"/>
              <a:t>! for Subcontinent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F767A23-80A8-7040-813D-7040CDA5E757}"/>
              </a:ext>
            </a:extLst>
          </p:cNvPr>
          <p:cNvSpPr/>
          <p:nvPr/>
        </p:nvSpPr>
        <p:spPr>
          <a:xfrm>
            <a:off x="952500" y="1811925"/>
            <a:ext cx="5626433" cy="980701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10CB6B4-178C-774B-B87B-E50FDCB9B082}"/>
              </a:ext>
            </a:extLst>
          </p:cNvPr>
          <p:cNvSpPr/>
          <p:nvPr/>
        </p:nvSpPr>
        <p:spPr>
          <a:xfrm>
            <a:off x="5196608" y="5840994"/>
            <a:ext cx="1382325" cy="17674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F268817-0E11-7145-8C46-FB5645C1B7B0}"/>
              </a:ext>
            </a:extLst>
          </p:cNvPr>
          <p:cNvSpPr/>
          <p:nvPr/>
        </p:nvSpPr>
        <p:spPr>
          <a:xfrm>
            <a:off x="5196607" y="5006913"/>
            <a:ext cx="1382325" cy="17674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68E6F2E-6B94-844E-AD1E-50DF5E8C88B5}"/>
              </a:ext>
            </a:extLst>
          </p:cNvPr>
          <p:cNvSpPr/>
          <p:nvPr/>
        </p:nvSpPr>
        <p:spPr>
          <a:xfrm>
            <a:off x="5196607" y="4411362"/>
            <a:ext cx="1382325" cy="29656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B41E395-7608-504F-8BC0-EC2C1E397D90}"/>
              </a:ext>
            </a:extLst>
          </p:cNvPr>
          <p:cNvSpPr/>
          <p:nvPr/>
        </p:nvSpPr>
        <p:spPr>
          <a:xfrm>
            <a:off x="6079237" y="3238420"/>
            <a:ext cx="499695" cy="661775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31841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769573-4989-8D49-B047-2624D8F9A72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35D2E2-4B6A-534B-BD52-2051CC7C21B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Picture 6" descr="A screenshot of a document&#10;&#10;Description automatically generated">
            <a:extLst>
              <a:ext uri="{FF2B5EF4-FFF2-40B4-BE49-F238E27FC236}">
                <a16:creationId xmlns:a16="http://schemas.microsoft.com/office/drawing/2014/main" id="{433D61FF-F438-D847-9B25-28F9F0E34D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2779" y="0"/>
            <a:ext cx="9286441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8650909" y="191850"/>
            <a:ext cx="2349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EurekAlert</a:t>
            </a:r>
            <a:r>
              <a:rPr lang="en-US" dirty="0"/>
              <a:t>! for Country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D57FCB5-701F-934C-B7CD-09DBC0B8D4B7}"/>
              </a:ext>
            </a:extLst>
          </p:cNvPr>
          <p:cNvSpPr/>
          <p:nvPr/>
        </p:nvSpPr>
        <p:spPr>
          <a:xfrm>
            <a:off x="1452779" y="1600200"/>
            <a:ext cx="5017595" cy="89452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9935A26-3007-F445-81E6-14631BEEE66A}"/>
              </a:ext>
            </a:extLst>
          </p:cNvPr>
          <p:cNvSpPr/>
          <p:nvPr/>
        </p:nvSpPr>
        <p:spPr>
          <a:xfrm>
            <a:off x="5987441" y="5067888"/>
            <a:ext cx="482933" cy="18991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D248B9C-4BC0-2648-BBCD-633C10CC81EF}"/>
              </a:ext>
            </a:extLst>
          </p:cNvPr>
          <p:cNvSpPr/>
          <p:nvPr/>
        </p:nvSpPr>
        <p:spPr>
          <a:xfrm>
            <a:off x="5987440" y="5799066"/>
            <a:ext cx="482933" cy="469653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7850735-0E5C-974F-873B-89C61E7FC0A5}"/>
              </a:ext>
            </a:extLst>
          </p:cNvPr>
          <p:cNvSpPr/>
          <p:nvPr/>
        </p:nvSpPr>
        <p:spPr>
          <a:xfrm>
            <a:off x="5970678" y="2786281"/>
            <a:ext cx="499695" cy="723681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2825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256F83A1-BA83-7B43-995E-67DA780027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3150" y="666750"/>
            <a:ext cx="7505700" cy="55245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757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ahoo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396C840-9E0A-BC41-8A13-FFEB7D4816B7}"/>
              </a:ext>
            </a:extLst>
          </p:cNvPr>
          <p:cNvSpPr/>
          <p:nvPr/>
        </p:nvSpPr>
        <p:spPr>
          <a:xfrm>
            <a:off x="5934269" y="1918026"/>
            <a:ext cx="499697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8F74014-F9A4-F44A-B43B-0070566863E0}"/>
              </a:ext>
            </a:extLst>
          </p:cNvPr>
          <p:cNvSpPr/>
          <p:nvPr/>
        </p:nvSpPr>
        <p:spPr>
          <a:xfrm>
            <a:off x="5514393" y="2267339"/>
            <a:ext cx="919574" cy="250339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9637D9E-351E-ED4C-BAD2-C55725A845C7}"/>
              </a:ext>
            </a:extLst>
          </p:cNvPr>
          <p:cNvSpPr/>
          <p:nvPr/>
        </p:nvSpPr>
        <p:spPr>
          <a:xfrm>
            <a:off x="5934268" y="3750067"/>
            <a:ext cx="499697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843710B-C9FC-F446-9932-23D7B3909B22}"/>
              </a:ext>
            </a:extLst>
          </p:cNvPr>
          <p:cNvSpPr/>
          <p:nvPr/>
        </p:nvSpPr>
        <p:spPr>
          <a:xfrm>
            <a:off x="5514393" y="4420654"/>
            <a:ext cx="919571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AEF203FF-67AF-D149-8C02-2302E95CBE63}"/>
              </a:ext>
            </a:extLst>
          </p:cNvPr>
          <p:cNvSpPr/>
          <p:nvPr/>
        </p:nvSpPr>
        <p:spPr>
          <a:xfrm>
            <a:off x="5934268" y="511376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EAD6117-389D-2A4D-9ACB-D675CDA2502D}"/>
              </a:ext>
            </a:extLst>
          </p:cNvPr>
          <p:cNvSpPr/>
          <p:nvPr/>
        </p:nvSpPr>
        <p:spPr>
          <a:xfrm>
            <a:off x="5934268" y="5349875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BC8A438-D396-7C4D-A02D-7856C8117881}"/>
              </a:ext>
            </a:extLst>
          </p:cNvPr>
          <p:cNvSpPr/>
          <p:nvPr/>
        </p:nvSpPr>
        <p:spPr>
          <a:xfrm>
            <a:off x="5929331" y="5663617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C7DA466-1FE2-CB48-B7BB-DB0C36E5B853}"/>
              </a:ext>
            </a:extLst>
          </p:cNvPr>
          <p:cNvSpPr/>
          <p:nvPr/>
        </p:nvSpPr>
        <p:spPr>
          <a:xfrm>
            <a:off x="5428090" y="2517678"/>
            <a:ext cx="1014188" cy="11086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0895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oogle</a:t>
            </a:r>
          </a:p>
        </p:txBody>
      </p:sp>
      <p:pic>
        <p:nvPicPr>
          <p:cNvPr id="7" name="Picture 6" descr="A screenshot of a document&#10;&#10;Description automatically generated">
            <a:extLst>
              <a:ext uri="{FF2B5EF4-FFF2-40B4-BE49-F238E27FC236}">
                <a16:creationId xmlns:a16="http://schemas.microsoft.com/office/drawing/2014/main" id="{8420DF21-1489-2C4B-91FA-CD44EF154F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0450" y="609600"/>
            <a:ext cx="7531100" cy="5638800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2EC6C32C-0DC8-FD48-8D99-7F37A793CD19}"/>
              </a:ext>
            </a:extLst>
          </p:cNvPr>
          <p:cNvSpPr/>
          <p:nvPr/>
        </p:nvSpPr>
        <p:spPr>
          <a:xfrm>
            <a:off x="5924643" y="1875155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F4071A2-7483-E644-8DEC-37145E96CA1C}"/>
              </a:ext>
            </a:extLst>
          </p:cNvPr>
          <p:cNvSpPr/>
          <p:nvPr/>
        </p:nvSpPr>
        <p:spPr>
          <a:xfrm>
            <a:off x="5924643" y="2244143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4AEAF40-4D3D-C54D-AC4E-49CE357FCE60}"/>
              </a:ext>
            </a:extLst>
          </p:cNvPr>
          <p:cNvSpPr/>
          <p:nvPr/>
        </p:nvSpPr>
        <p:spPr>
          <a:xfrm>
            <a:off x="5921287" y="5741636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73A3EB3-8975-6047-9162-ABD5FE08501C}"/>
              </a:ext>
            </a:extLst>
          </p:cNvPr>
          <p:cNvSpPr/>
          <p:nvPr/>
        </p:nvSpPr>
        <p:spPr>
          <a:xfrm>
            <a:off x="5921287" y="1546754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F635D03-8F9D-6246-9332-BC714926124F}"/>
              </a:ext>
            </a:extLst>
          </p:cNvPr>
          <p:cNvSpPr/>
          <p:nvPr/>
        </p:nvSpPr>
        <p:spPr>
          <a:xfrm>
            <a:off x="6037311" y="2900917"/>
            <a:ext cx="391069" cy="342079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1037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6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N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3FD4D4B4-1468-DC43-9B92-1CDB04F4E7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4100" y="641350"/>
            <a:ext cx="7543800" cy="55753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BDED6958-4E66-FF41-B017-519818D5095B}"/>
              </a:ext>
            </a:extLst>
          </p:cNvPr>
          <p:cNvSpPr/>
          <p:nvPr/>
        </p:nvSpPr>
        <p:spPr>
          <a:xfrm>
            <a:off x="5921287" y="1949566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0922D9F-DF72-0D4E-B244-389648A383B8}"/>
              </a:ext>
            </a:extLst>
          </p:cNvPr>
          <p:cNvSpPr/>
          <p:nvPr/>
        </p:nvSpPr>
        <p:spPr>
          <a:xfrm>
            <a:off x="2324101" y="2185680"/>
            <a:ext cx="4096882" cy="324437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B39B386-DCA2-5740-A046-DECEC3964ECB}"/>
              </a:ext>
            </a:extLst>
          </p:cNvPr>
          <p:cNvSpPr/>
          <p:nvPr/>
        </p:nvSpPr>
        <p:spPr>
          <a:xfrm>
            <a:off x="5921286" y="5366096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C9D49A8-1563-0A4B-B741-906A7EE93672}"/>
              </a:ext>
            </a:extLst>
          </p:cNvPr>
          <p:cNvSpPr/>
          <p:nvPr/>
        </p:nvSpPr>
        <p:spPr>
          <a:xfrm>
            <a:off x="5921285" y="5715269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4BA9025-30B1-DD49-A1A8-C5333F95A57D}"/>
              </a:ext>
            </a:extLst>
          </p:cNvPr>
          <p:cNvSpPr/>
          <p:nvPr/>
        </p:nvSpPr>
        <p:spPr>
          <a:xfrm>
            <a:off x="5921285" y="1600393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3F2B434-14F1-A34D-883A-F16841ADE973}"/>
              </a:ext>
            </a:extLst>
          </p:cNvPr>
          <p:cNvSpPr/>
          <p:nvPr/>
        </p:nvSpPr>
        <p:spPr>
          <a:xfrm>
            <a:off x="5921285" y="3100656"/>
            <a:ext cx="499695" cy="393085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84079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2077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e New York Times</a:t>
            </a:r>
          </a:p>
        </p:txBody>
      </p:sp>
      <p:pic>
        <p:nvPicPr>
          <p:cNvPr id="5" name="Picture 4" descr="A document with numbers and text&#10;&#10;Description automatically generated">
            <a:extLst>
              <a:ext uri="{FF2B5EF4-FFF2-40B4-BE49-F238E27FC236}">
                <a16:creationId xmlns:a16="http://schemas.microsoft.com/office/drawing/2014/main" id="{6FFB7F3A-9335-1E4A-ACE3-008D32DED4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6800" y="647700"/>
            <a:ext cx="7518400" cy="55626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6922C4B5-164D-3549-A9EA-CA28D3710E4B}"/>
              </a:ext>
            </a:extLst>
          </p:cNvPr>
          <p:cNvSpPr/>
          <p:nvPr/>
        </p:nvSpPr>
        <p:spPr>
          <a:xfrm>
            <a:off x="5939215" y="1923648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88FE361-17C5-FD4C-9A00-2F75B15C5D01}"/>
              </a:ext>
            </a:extLst>
          </p:cNvPr>
          <p:cNvSpPr/>
          <p:nvPr/>
        </p:nvSpPr>
        <p:spPr>
          <a:xfrm>
            <a:off x="2336801" y="2172122"/>
            <a:ext cx="4102110" cy="477415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C64CAC8-EAF5-BA4A-AB32-9A806BED2083}"/>
              </a:ext>
            </a:extLst>
          </p:cNvPr>
          <p:cNvSpPr/>
          <p:nvPr/>
        </p:nvSpPr>
        <p:spPr>
          <a:xfrm>
            <a:off x="5939215" y="3762638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03221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2157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he Washington Post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E6014C08-ADCD-E74D-B2B5-B660F32833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1400" y="654050"/>
            <a:ext cx="7569200" cy="55499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BB80D1CF-A399-FA47-BED5-7CCC3807DF99}"/>
              </a:ext>
            </a:extLst>
          </p:cNvPr>
          <p:cNvSpPr/>
          <p:nvPr/>
        </p:nvSpPr>
        <p:spPr>
          <a:xfrm>
            <a:off x="5929884" y="1952499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08D751B-C9B3-7042-BA46-DB6EC76320E1}"/>
              </a:ext>
            </a:extLst>
          </p:cNvPr>
          <p:cNvSpPr/>
          <p:nvPr/>
        </p:nvSpPr>
        <p:spPr>
          <a:xfrm>
            <a:off x="2311401" y="2188614"/>
            <a:ext cx="4118178" cy="376238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8CB7C46-0428-024C-9C4E-CA4B7ACEFD21}"/>
              </a:ext>
            </a:extLst>
          </p:cNvPr>
          <p:cNvSpPr/>
          <p:nvPr/>
        </p:nvSpPr>
        <p:spPr>
          <a:xfrm>
            <a:off x="5874687" y="5735637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89270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553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OX</a:t>
            </a:r>
          </a:p>
        </p:txBody>
      </p:sp>
      <p:pic>
        <p:nvPicPr>
          <p:cNvPr id="5" name="Picture 4" descr="A document with numbers and text&#10;&#10;Description automatically generated">
            <a:extLst>
              <a:ext uri="{FF2B5EF4-FFF2-40B4-BE49-F238E27FC236}">
                <a16:creationId xmlns:a16="http://schemas.microsoft.com/office/drawing/2014/main" id="{47DEB11B-9EAC-F24D-A0BF-8933206EDF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7750" y="654050"/>
            <a:ext cx="7556500" cy="55499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7879301A-BF86-A14D-B5C2-520ECD5FB9CB}"/>
              </a:ext>
            </a:extLst>
          </p:cNvPr>
          <p:cNvSpPr/>
          <p:nvPr/>
        </p:nvSpPr>
        <p:spPr>
          <a:xfrm>
            <a:off x="5929884" y="1924508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3B1AD3A-EDC8-864D-935E-9BD8203651CB}"/>
              </a:ext>
            </a:extLst>
          </p:cNvPr>
          <p:cNvSpPr/>
          <p:nvPr/>
        </p:nvSpPr>
        <p:spPr>
          <a:xfrm>
            <a:off x="5929883" y="3762899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C6D4EB5-45CF-A844-B85F-11F2706D0CC5}"/>
              </a:ext>
            </a:extLst>
          </p:cNvPr>
          <p:cNvSpPr/>
          <p:nvPr/>
        </p:nvSpPr>
        <p:spPr>
          <a:xfrm>
            <a:off x="5514392" y="4438329"/>
            <a:ext cx="91518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B6C1721-C973-7D49-A5CD-EEE5F29401F6}"/>
              </a:ext>
            </a:extLst>
          </p:cNvPr>
          <p:cNvSpPr/>
          <p:nvPr/>
        </p:nvSpPr>
        <p:spPr>
          <a:xfrm>
            <a:off x="5907455" y="5663617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AD779B0-9A30-E249-B74E-1C00DC3E5F57}"/>
              </a:ext>
            </a:extLst>
          </p:cNvPr>
          <p:cNvSpPr/>
          <p:nvPr/>
        </p:nvSpPr>
        <p:spPr>
          <a:xfrm>
            <a:off x="5428090" y="2517678"/>
            <a:ext cx="1014188" cy="110863"/>
          </a:xfrm>
          <a:prstGeom prst="rect">
            <a:avLst/>
          </a:prstGeom>
          <a:solidFill>
            <a:schemeClr val="accent1">
              <a:lumMod val="75000"/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497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566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BC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5921CB82-8351-534A-AB0B-3BA5A736EE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1400" y="654050"/>
            <a:ext cx="7569200" cy="55499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EFB866A5-74AC-8442-BB3A-EF6121E67CDF}"/>
              </a:ext>
            </a:extLst>
          </p:cNvPr>
          <p:cNvSpPr/>
          <p:nvPr/>
        </p:nvSpPr>
        <p:spPr>
          <a:xfrm>
            <a:off x="5514392" y="2244142"/>
            <a:ext cx="905855" cy="284453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2A489BC-BA27-BD44-A51A-FAC59AA17E8A}"/>
              </a:ext>
            </a:extLst>
          </p:cNvPr>
          <p:cNvSpPr/>
          <p:nvPr/>
        </p:nvSpPr>
        <p:spPr>
          <a:xfrm>
            <a:off x="5920552" y="1937966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303069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E714298-742E-7B41-8B8D-59419952779E}"/>
              </a:ext>
            </a:extLst>
          </p:cNvPr>
          <p:cNvSpPr txBox="1"/>
          <p:nvPr/>
        </p:nvSpPr>
        <p:spPr>
          <a:xfrm>
            <a:off x="368300" y="228600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NN</a:t>
            </a:r>
          </a:p>
        </p:txBody>
      </p:sp>
      <p:pic>
        <p:nvPicPr>
          <p:cNvPr id="5" name="Picture 4" descr="A screenshot of a document&#10;&#10;Description automatically generated">
            <a:extLst>
              <a:ext uri="{FF2B5EF4-FFF2-40B4-BE49-F238E27FC236}">
                <a16:creationId xmlns:a16="http://schemas.microsoft.com/office/drawing/2014/main" id="{2C354FC1-4FB7-1C4F-8A1A-17B6CE9076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7750" y="635000"/>
            <a:ext cx="7556500" cy="5588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AE438076-8A94-2749-A79E-816F32731999}"/>
              </a:ext>
            </a:extLst>
          </p:cNvPr>
          <p:cNvSpPr/>
          <p:nvPr/>
        </p:nvSpPr>
        <p:spPr>
          <a:xfrm>
            <a:off x="5920552" y="1600200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3F17193-7A7B-5248-A6FA-E032E5785A04}"/>
              </a:ext>
            </a:extLst>
          </p:cNvPr>
          <p:cNvSpPr/>
          <p:nvPr/>
        </p:nvSpPr>
        <p:spPr>
          <a:xfrm>
            <a:off x="5920551" y="1920551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B30C519-F263-BA40-A9B0-F6F977F86137}"/>
              </a:ext>
            </a:extLst>
          </p:cNvPr>
          <p:cNvSpPr/>
          <p:nvPr/>
        </p:nvSpPr>
        <p:spPr>
          <a:xfrm>
            <a:off x="5920551" y="2250866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F6F5057-A1BD-D54C-BEE3-D29DE1DEB3FF}"/>
              </a:ext>
            </a:extLst>
          </p:cNvPr>
          <p:cNvSpPr/>
          <p:nvPr/>
        </p:nvSpPr>
        <p:spPr>
          <a:xfrm>
            <a:off x="5920551" y="3280668"/>
            <a:ext cx="499695" cy="144040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CED8A42-FD6D-2842-AFB8-21A7FAE01FE6}"/>
              </a:ext>
            </a:extLst>
          </p:cNvPr>
          <p:cNvSpPr/>
          <p:nvPr/>
        </p:nvSpPr>
        <p:spPr>
          <a:xfrm>
            <a:off x="5850294" y="5663617"/>
            <a:ext cx="569951" cy="168016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58516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8</TotalTime>
  <Words>55</Words>
  <Application>Microsoft Macintosh PowerPoint</Application>
  <PresentationFormat>Widescreen</PresentationFormat>
  <Paragraphs>23</Paragraphs>
  <Slides>19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Mixed-effects logistic regression model outputs for individual news outlets and EurekAlert!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Outputs</dc:title>
  <dc:creator>Jenny Ji</dc:creator>
  <cp:lastModifiedBy>Jenny Ji</cp:lastModifiedBy>
  <cp:revision>6</cp:revision>
  <dcterms:created xsi:type="dcterms:W3CDTF">2025-03-06T00:56:24Z</dcterms:created>
  <dcterms:modified xsi:type="dcterms:W3CDTF">2025-03-09T18:50:33Z</dcterms:modified>
</cp:coreProperties>
</file>